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276600" cy="4572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424A9-5F32-4059-8A88-488001E688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27842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46240" y="2753640"/>
            <a:ext cx="27842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2D770-0521-47DF-BC38-6DBA4655DF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67328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46240" y="27536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673280" y="27536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13BA3-3B0C-49DF-A3B7-2356A00B29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88000" y="13208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129400" y="13208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46240" y="27536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88000" y="27536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129400" y="2753640"/>
            <a:ext cx="89640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1EAFC-E04A-4576-A0E0-03F7DBCA23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46240" y="1320840"/>
            <a:ext cx="278424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9765F-F6CD-47E3-9C64-77712608FE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27842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B6AEE-FC9F-4576-960C-80D31E2403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13586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673280" y="1320840"/>
            <a:ext cx="13586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5C013-AEED-4010-A1A3-F354155D7F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FFD7AA-F01C-4339-B024-3AA45FE251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46240" y="406080"/>
            <a:ext cx="2784240" cy="3534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671EC-8220-4B04-A2E9-B22DAFB2EE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673280" y="1320840"/>
            <a:ext cx="13586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46240" y="27536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29009-090C-4901-8A78-1835B2E50A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13586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67328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673280" y="27536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EA872-B0EC-41E1-A5B4-A6AD846068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4624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673280" y="1320840"/>
            <a:ext cx="13586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46240" y="2753640"/>
            <a:ext cx="2784240" cy="130824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C6BD9-1CAC-4F8B-8471-9A84F356AB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46240" y="406080"/>
            <a:ext cx="2784240" cy="7621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2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46240" y="1320840"/>
            <a:ext cx="2784240" cy="274320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rmAutofit/>
          </a:bodyPr>
          <a:p>
            <a:pPr marL="168120" indent="-168120">
              <a:spcBef>
                <a:spcPts val="400"/>
              </a:spcBef>
              <a:buClr>
                <a:srgbClr val="000000"/>
              </a:buClr>
              <a:buFont typeface="Times New Roman"/>
              <a:buChar char="•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1" marL="365040" indent="-141120">
              <a:spcBef>
                <a:spcPts val="400"/>
              </a:spcBef>
              <a:buClr>
                <a:srgbClr val="000000"/>
              </a:buClr>
              <a:buFont typeface="Times New Roman"/>
              <a:buChar char="–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2" marL="560520" indent="-112680">
              <a:spcBef>
                <a:spcPts val="400"/>
              </a:spcBef>
              <a:buClr>
                <a:srgbClr val="000000"/>
              </a:buClr>
              <a:buFont typeface="Times New Roman"/>
              <a:buChar char="•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3" marL="784080" indent="-110880">
              <a:spcBef>
                <a:spcPts val="400"/>
              </a:spcBef>
              <a:buClr>
                <a:srgbClr val="000000"/>
              </a:buClr>
              <a:buFont typeface="Times New Roman"/>
              <a:buChar char="–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4" marL="1009800" indent="-113040">
              <a:spcBef>
                <a:spcPts val="400"/>
              </a:spcBef>
              <a:buClr>
                <a:srgbClr val="000000"/>
              </a:buClr>
              <a:buFont typeface="Times New Roman"/>
              <a:buChar char="»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5" marL="1009800" indent="-113040">
              <a:spcBef>
                <a:spcPts val="400"/>
              </a:spcBef>
              <a:buClr>
                <a:srgbClr val="000000"/>
              </a:buClr>
              <a:buFont typeface="Times New Roman"/>
              <a:buChar char="»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lvl="6" marL="1009800" indent="-113040">
              <a:spcBef>
                <a:spcPts val="400"/>
              </a:spcBef>
              <a:buClr>
                <a:srgbClr val="000000"/>
              </a:buClr>
              <a:buFont typeface="Times New Roman"/>
              <a:buChar char="»"/>
              <a:tabLst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46240" y="4165200"/>
            <a:ext cx="682560" cy="3049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  <a:defRPr b="0" lang="en-GB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19240" y="4165200"/>
            <a:ext cx="1038240" cy="3049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Autofit/>
          </a:bodyPr>
          <a:lstStyle>
            <a:lvl1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  <a:defRPr b="0" lang="en-GB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347920" y="4165200"/>
            <a:ext cx="682560" cy="304920"/>
          </a:xfrm>
          <a:prstGeom prst="rect">
            <a:avLst/>
          </a:prstGeom>
          <a:noFill/>
          <a:ln w="0">
            <a:noFill/>
          </a:ln>
        </p:spPr>
        <p:txBody>
          <a:bodyPr lIns="45000" rIns="45000" tIns="22320" bIns="22320" anchor="t">
            <a:noAutofit/>
          </a:bodyPr>
          <a:lstStyle>
            <a:lvl1pPr indent="0" algn="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  <a:defRPr b="0" lang="en-GB" sz="7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47840"/>
                <a:tab algn="l" pos="895320"/>
                <a:tab algn="l" pos="1343160"/>
                <a:tab algn="l" pos="1790640"/>
                <a:tab algn="l" pos="2238480"/>
                <a:tab algn="l" pos="2685960"/>
                <a:tab algn="l" pos="3133800"/>
                <a:tab algn="l" pos="3581280"/>
                <a:tab algn="l" pos="4029120"/>
                <a:tab algn="l" pos="4476600"/>
                <a:tab algn="l" pos="4924440"/>
                <a:tab algn="l" pos="5372280"/>
                <a:tab algn="l" pos="5819760"/>
                <a:tab algn="l" pos="6267600"/>
                <a:tab algn="l" pos="6715080"/>
                <a:tab algn="l" pos="7162920"/>
                <a:tab algn="l" pos="7610400"/>
                <a:tab algn="l" pos="8058240"/>
                <a:tab algn="l" pos="8505720"/>
                <a:tab algn="l" pos="8953560"/>
              </a:tabLst>
            </a:pPr>
            <a:fld id="{192BA295-3895-4B3C-AEDB-059FCE28EAAF}" type="slidenum">
              <a:rPr b="0" lang="en-GB" sz="7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3436920" cy="4606920"/>
            <a:chOff x="0" y="0"/>
            <a:chExt cx="3436920" cy="4606920"/>
          </a:xfrm>
        </p:grpSpPr>
        <p:graphicFrame>
          <p:nvGraphicFramePr>
            <p:cNvPr id="42" name=""/>
            <p:cNvGraphicFramePr/>
            <p:nvPr/>
          </p:nvGraphicFramePr>
          <p:xfrm>
            <a:off x="103320" y="0"/>
            <a:ext cx="3333600" cy="28479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03320" y="0"/>
                      <a:ext cx="3333600" cy="2847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1587600" y="2656080"/>
              <a:ext cx="34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pi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-915840" y="1161720"/>
              <a:ext cx="207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lative viral fitness AS/(AS+HIV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7640" y="3052800"/>
              <a:ext cx="320040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dditional file 3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Graphic quanti-fication of the 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MS Mincho"/>
                </a:rPr>
                <a:t>relative viral abundance in SupT1 cells. The densities of the PCR products from Supplementary figure 1 were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calculated with the ImageJ software by the formula: (density of variant band)/(combined densities of variant + HIV bands) after background intensities were subtracted in each case. 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6T13:12:57Z</dcterms:created>
  <dc:creator>Raymond Huismans</dc:creator>
  <dc:description/>
  <dc:language>en-US</dc:language>
  <cp:lastModifiedBy>Raymond Huismans</cp:lastModifiedBy>
  <dcterms:modified xsi:type="dcterms:W3CDTF">2007-02-26T11:17:25Z</dcterms:modified>
  <cp:revision>13</cp:revision>
  <dc:subject/>
  <dc:title>PowerPoint Presentation</dc:title>
</cp:coreProperties>
</file>